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36" r:id="rId2"/>
    <p:sldId id="337" r:id="rId3"/>
    <p:sldId id="338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967" autoAdjust="0"/>
    <p:restoredTop sz="94177" autoAdjust="0"/>
  </p:normalViewPr>
  <p:slideViewPr>
    <p:cSldViewPr snapToGrid="0">
      <p:cViewPr varScale="1">
        <p:scale>
          <a:sx n="97" d="100"/>
          <a:sy n="97" d="100"/>
        </p:scale>
        <p:origin x="96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30F53-4FD1-4C5F-A2E3-A298EFF3ED91}" type="datetimeFigureOut">
              <a:rPr kumimoji="1" lang="ja-JP" altLang="en-US" smtClean="0"/>
              <a:t>2025/8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B48F7-4F34-46AE-85D8-DC01021C2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59349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30F53-4FD1-4C5F-A2E3-A298EFF3ED91}" type="datetimeFigureOut">
              <a:rPr kumimoji="1" lang="ja-JP" altLang="en-US" smtClean="0"/>
              <a:t>2025/8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B48F7-4F34-46AE-85D8-DC01021C2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0190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30F53-4FD1-4C5F-A2E3-A298EFF3ED91}" type="datetimeFigureOut">
              <a:rPr kumimoji="1" lang="ja-JP" altLang="en-US" smtClean="0"/>
              <a:t>2025/8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B48F7-4F34-46AE-85D8-DC01021C2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76754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30F53-4FD1-4C5F-A2E3-A298EFF3ED91}" type="datetimeFigureOut">
              <a:rPr kumimoji="1" lang="ja-JP" altLang="en-US" smtClean="0"/>
              <a:t>2025/8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B48F7-4F34-46AE-85D8-DC01021C2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39304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30F53-4FD1-4C5F-A2E3-A298EFF3ED91}" type="datetimeFigureOut">
              <a:rPr kumimoji="1" lang="ja-JP" altLang="en-US" smtClean="0"/>
              <a:t>2025/8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B48F7-4F34-46AE-85D8-DC01021C2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78931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30F53-4FD1-4C5F-A2E3-A298EFF3ED91}" type="datetimeFigureOut">
              <a:rPr kumimoji="1" lang="ja-JP" altLang="en-US" smtClean="0"/>
              <a:t>2025/8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B48F7-4F34-46AE-85D8-DC01021C2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42326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30F53-4FD1-4C5F-A2E3-A298EFF3ED91}" type="datetimeFigureOut">
              <a:rPr kumimoji="1" lang="ja-JP" altLang="en-US" smtClean="0"/>
              <a:t>2025/8/2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B48F7-4F34-46AE-85D8-DC01021C2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45196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30F53-4FD1-4C5F-A2E3-A298EFF3ED91}" type="datetimeFigureOut">
              <a:rPr kumimoji="1" lang="ja-JP" altLang="en-US" smtClean="0"/>
              <a:t>2025/8/2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B48F7-4F34-46AE-85D8-DC01021C2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62896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30F53-4FD1-4C5F-A2E3-A298EFF3ED91}" type="datetimeFigureOut">
              <a:rPr kumimoji="1" lang="ja-JP" altLang="en-US" smtClean="0"/>
              <a:t>2025/8/2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B48F7-4F34-46AE-85D8-DC01021C2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0048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30F53-4FD1-4C5F-A2E3-A298EFF3ED91}" type="datetimeFigureOut">
              <a:rPr kumimoji="1" lang="ja-JP" altLang="en-US" smtClean="0"/>
              <a:t>2025/8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B48F7-4F34-46AE-85D8-DC01021C2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6386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30F53-4FD1-4C5F-A2E3-A298EFF3ED91}" type="datetimeFigureOut">
              <a:rPr kumimoji="1" lang="ja-JP" altLang="en-US" smtClean="0"/>
              <a:t>2025/8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B48F7-4F34-46AE-85D8-DC01021C2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28333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430F53-4FD1-4C5F-A2E3-A298EFF3ED91}" type="datetimeFigureOut">
              <a:rPr kumimoji="1" lang="ja-JP" altLang="en-US" smtClean="0"/>
              <a:t>2025/8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5B48F7-4F34-46AE-85D8-DC01021C2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06147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C7BCC02E-8C8F-3E5D-7375-D3743C2A8C70}"/>
              </a:ext>
            </a:extLst>
          </p:cNvPr>
          <p:cNvGraphicFramePr>
            <a:graphicFrameLocks noGrp="1"/>
          </p:cNvGraphicFramePr>
          <p:nvPr/>
        </p:nvGraphicFramePr>
        <p:xfrm>
          <a:off x="628650" y="1275595"/>
          <a:ext cx="7886700" cy="3032937"/>
        </p:xfrm>
        <a:graphic>
          <a:graphicData uri="http://schemas.openxmlformats.org/drawingml/2006/table">
            <a:tbl>
              <a:tblPr/>
              <a:tblGrid>
                <a:gridCol w="571270">
                  <a:extLst>
                    <a:ext uri="{9D8B030D-6E8A-4147-A177-3AD203B41FA5}">
                      <a16:colId xmlns:a16="http://schemas.microsoft.com/office/drawing/2014/main" val="978705014"/>
                    </a:ext>
                  </a:extLst>
                </a:gridCol>
                <a:gridCol w="867005">
                  <a:extLst>
                    <a:ext uri="{9D8B030D-6E8A-4147-A177-3AD203B41FA5}">
                      <a16:colId xmlns:a16="http://schemas.microsoft.com/office/drawing/2014/main" val="1685484691"/>
                    </a:ext>
                  </a:extLst>
                </a:gridCol>
                <a:gridCol w="2386061">
                  <a:extLst>
                    <a:ext uri="{9D8B030D-6E8A-4147-A177-3AD203B41FA5}">
                      <a16:colId xmlns:a16="http://schemas.microsoft.com/office/drawing/2014/main" val="1762552730"/>
                    </a:ext>
                  </a:extLst>
                </a:gridCol>
                <a:gridCol w="571270">
                  <a:extLst>
                    <a:ext uri="{9D8B030D-6E8A-4147-A177-3AD203B41FA5}">
                      <a16:colId xmlns:a16="http://schemas.microsoft.com/office/drawing/2014/main" val="2307132302"/>
                    </a:ext>
                  </a:extLst>
                </a:gridCol>
                <a:gridCol w="571270">
                  <a:extLst>
                    <a:ext uri="{9D8B030D-6E8A-4147-A177-3AD203B41FA5}">
                      <a16:colId xmlns:a16="http://schemas.microsoft.com/office/drawing/2014/main" val="3449148051"/>
                    </a:ext>
                  </a:extLst>
                </a:gridCol>
                <a:gridCol w="571270">
                  <a:extLst>
                    <a:ext uri="{9D8B030D-6E8A-4147-A177-3AD203B41FA5}">
                      <a16:colId xmlns:a16="http://schemas.microsoft.com/office/drawing/2014/main" val="3371722258"/>
                    </a:ext>
                  </a:extLst>
                </a:gridCol>
                <a:gridCol w="571270">
                  <a:extLst>
                    <a:ext uri="{9D8B030D-6E8A-4147-A177-3AD203B41FA5}">
                      <a16:colId xmlns:a16="http://schemas.microsoft.com/office/drawing/2014/main" val="4159772128"/>
                    </a:ext>
                  </a:extLst>
                </a:gridCol>
                <a:gridCol w="1206014">
                  <a:extLst>
                    <a:ext uri="{9D8B030D-6E8A-4147-A177-3AD203B41FA5}">
                      <a16:colId xmlns:a16="http://schemas.microsoft.com/office/drawing/2014/main" val="2985386815"/>
                    </a:ext>
                  </a:extLst>
                </a:gridCol>
                <a:gridCol w="571270">
                  <a:extLst>
                    <a:ext uri="{9D8B030D-6E8A-4147-A177-3AD203B41FA5}">
                      <a16:colId xmlns:a16="http://schemas.microsoft.com/office/drawing/2014/main" val="2910412419"/>
                    </a:ext>
                  </a:extLst>
                </a:gridCol>
              </a:tblGrid>
              <a:tr h="389042">
                <a:tc gridSpan="3">
                  <a:txBody>
                    <a:bodyPr/>
                    <a:lstStyle/>
                    <a:p>
                      <a:pPr algn="l" fontAlgn="ctr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940" marR="7940" marT="79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940" marR="7940" marT="79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940" marR="7940" marT="79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940" marR="7940" marT="79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940" marR="7940" marT="79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940" marR="7940" marT="79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940" marR="7940" marT="79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80091500"/>
                  </a:ext>
                </a:extLst>
              </a:tr>
              <a:tr h="4208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FW or RV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Name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Sequence(5'- 3')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base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Tm1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Tm2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uM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Location               (BKV Gardner St.)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17352868"/>
                  </a:ext>
                </a:extLst>
              </a:tr>
              <a:tr h="317585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　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FW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08523_01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CTCTTCTGTTCCATAGGTTG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1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4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0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0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4579 - 4599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58449034"/>
                  </a:ext>
                </a:extLst>
              </a:tr>
              <a:tr h="317585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　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RV</a:t>
                      </a:r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08523_02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CTTGCCTGCTTTGCTGTG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9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7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5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0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4375 - 4357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4443330"/>
                  </a:ext>
                </a:extLst>
              </a:tr>
              <a:tr h="317585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　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FW</a:t>
                      </a:r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08523_03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CTCCACACCCTTACTACTT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0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5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0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0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4 - 83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34267899"/>
                  </a:ext>
                </a:extLst>
              </a:tr>
              <a:tr h="317585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　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RV</a:t>
                      </a:r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08523_04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AAGCAGTAGATACAGTTTTAG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2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2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0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0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825 - 3804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16051341"/>
                  </a:ext>
                </a:extLst>
              </a:tr>
              <a:tr h="317585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　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FW</a:t>
                      </a:r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08523_05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TGCTGGAATTTTGTAGAGGTGA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2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4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3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0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31 -552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96268577"/>
                  </a:ext>
                </a:extLst>
              </a:tr>
              <a:tr h="317585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　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FW</a:t>
                      </a:r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08523_07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GTCCCAGGTAATGAATACTGA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1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4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49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0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158 - 2178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48105141"/>
                  </a:ext>
                </a:extLst>
              </a:tr>
              <a:tr h="317585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　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FW</a:t>
                      </a:r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08523_08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AACAGGTGCTTTTATTGTACAT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3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1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0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0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688 - 2710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16916981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FDAA62A-315E-F340-FD96-0CE53E188A3B}"/>
              </a:ext>
            </a:extLst>
          </p:cNvPr>
          <p:cNvSpPr txBox="1"/>
          <p:nvPr/>
        </p:nvSpPr>
        <p:spPr>
          <a:xfrm>
            <a:off x="333375" y="723900"/>
            <a:ext cx="20233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Data 1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1AAD858-9E88-8017-19C2-28B1177BB2BA}"/>
              </a:ext>
            </a:extLst>
          </p:cNvPr>
          <p:cNvSpPr txBox="1"/>
          <p:nvPr/>
        </p:nvSpPr>
        <p:spPr>
          <a:xfrm>
            <a:off x="2453047" y="734206"/>
            <a:ext cx="28600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s used for</a:t>
            </a:r>
            <a:r>
              <a:rPr kumimoji="1"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</a:t>
            </a:r>
            <a:r>
              <a:rPr kumimoji="1"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lking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780380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FFD0C4D-BFF7-F94A-AFF6-6CA5332A3DC6}"/>
              </a:ext>
            </a:extLst>
          </p:cNvPr>
          <p:cNvSpPr txBox="1"/>
          <p:nvPr/>
        </p:nvSpPr>
        <p:spPr>
          <a:xfrm>
            <a:off x="504825" y="219075"/>
            <a:ext cx="207460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Data  2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5E65288A-747D-5EEE-7804-C4D504641667}"/>
              </a:ext>
            </a:extLst>
          </p:cNvPr>
          <p:cNvGraphicFramePr>
            <a:graphicFrameLocks noGrp="1"/>
          </p:cNvGraphicFramePr>
          <p:nvPr/>
        </p:nvGraphicFramePr>
        <p:xfrm>
          <a:off x="1247776" y="1028700"/>
          <a:ext cx="5505450" cy="5143497"/>
        </p:xfrm>
        <a:graphic>
          <a:graphicData uri="http://schemas.openxmlformats.org/drawingml/2006/table">
            <a:tbl>
              <a:tblPr/>
              <a:tblGrid>
                <a:gridCol w="944806">
                  <a:extLst>
                    <a:ext uri="{9D8B030D-6E8A-4147-A177-3AD203B41FA5}">
                      <a16:colId xmlns:a16="http://schemas.microsoft.com/office/drawing/2014/main" val="2918548075"/>
                    </a:ext>
                  </a:extLst>
                </a:gridCol>
                <a:gridCol w="511474">
                  <a:extLst>
                    <a:ext uri="{9D8B030D-6E8A-4147-A177-3AD203B41FA5}">
                      <a16:colId xmlns:a16="http://schemas.microsoft.com/office/drawing/2014/main" val="4293223756"/>
                    </a:ext>
                  </a:extLst>
                </a:gridCol>
                <a:gridCol w="646446">
                  <a:extLst>
                    <a:ext uri="{9D8B030D-6E8A-4147-A177-3AD203B41FA5}">
                      <a16:colId xmlns:a16="http://schemas.microsoft.com/office/drawing/2014/main" val="3265300266"/>
                    </a:ext>
                  </a:extLst>
                </a:gridCol>
                <a:gridCol w="909287">
                  <a:extLst>
                    <a:ext uri="{9D8B030D-6E8A-4147-A177-3AD203B41FA5}">
                      <a16:colId xmlns:a16="http://schemas.microsoft.com/office/drawing/2014/main" val="2226096994"/>
                    </a:ext>
                  </a:extLst>
                </a:gridCol>
                <a:gridCol w="447541">
                  <a:extLst>
                    <a:ext uri="{9D8B030D-6E8A-4147-A177-3AD203B41FA5}">
                      <a16:colId xmlns:a16="http://schemas.microsoft.com/office/drawing/2014/main" val="384704112"/>
                    </a:ext>
                  </a:extLst>
                </a:gridCol>
                <a:gridCol w="2045896">
                  <a:extLst>
                    <a:ext uri="{9D8B030D-6E8A-4147-A177-3AD203B41FA5}">
                      <a16:colId xmlns:a16="http://schemas.microsoft.com/office/drawing/2014/main" val="1797111779"/>
                    </a:ext>
                  </a:extLst>
                </a:gridCol>
              </a:tblGrid>
              <a:tr h="646269">
                <a:tc gridSpan="6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track name=IAD178171_Designed description=Covered_bases solution_type=182 AmpliSeq_Version=7.06 workflow=dna ionVersion=4.0 db=BKV reference=BKV type=bedDetail color=77,175,74 priority=2.0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30457596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3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48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14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1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4408795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72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02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15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2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81305679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91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01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16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1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76185844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90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10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17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2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38822288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99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017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18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1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17105483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006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222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19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2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20704657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211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408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20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1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30294530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397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612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21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2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73322789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601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827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22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1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41083347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816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996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23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2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99307413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985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186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24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1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58523231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175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390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25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2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0805186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379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584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26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1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24196674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573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779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27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2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24945950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768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864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28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1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41179490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853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060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29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2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93706909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049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254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30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1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7486028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243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469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31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2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96662427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458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672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32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1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34858051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660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853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33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2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65008385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841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018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34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1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17331484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007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218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35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2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44800562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207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394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36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1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28804297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383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516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37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2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87485189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505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718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38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1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15551556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707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923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39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2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62567990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912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139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40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1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77122170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6C0CBC4-F357-83F3-07AA-7237EA09CFCF}"/>
              </a:ext>
            </a:extLst>
          </p:cNvPr>
          <p:cNvSpPr txBox="1"/>
          <p:nvPr/>
        </p:nvSpPr>
        <p:spPr>
          <a:xfrm>
            <a:off x="2596556" y="209550"/>
            <a:ext cx="57743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plicon location of NGS sequencing on the reference sequences 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971035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図 26">
            <a:extLst>
              <a:ext uri="{FF2B5EF4-FFF2-40B4-BE49-F238E27FC236}">
                <a16:creationId xmlns:a16="http://schemas.microsoft.com/office/drawing/2014/main" id="{E3DB4175-0ADE-DB97-FC42-94AAFEEFCA6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70342" y="1252843"/>
            <a:ext cx="4420375" cy="2707531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592A6BD-A76D-0DE5-7270-9BFEA9B78850}"/>
              </a:ext>
            </a:extLst>
          </p:cNvPr>
          <p:cNvSpPr txBox="1"/>
          <p:nvPr/>
        </p:nvSpPr>
        <p:spPr>
          <a:xfrm>
            <a:off x="367338" y="215017"/>
            <a:ext cx="20858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ymentary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ta 3 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C85B9D64-896B-C1E2-620D-9B53C4E1770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2947" y="1254832"/>
            <a:ext cx="4358841" cy="2353364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CAABC753-7690-A6A5-CD82-686CE802E0F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8002" y="4043950"/>
            <a:ext cx="4358842" cy="2466347"/>
          </a:xfrm>
          <a:prstGeom prst="rect">
            <a:avLst/>
          </a:prstGeom>
        </p:spPr>
      </p:pic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E9C8987B-3E2F-99C8-DAA9-98F1B3EE5A2B}"/>
              </a:ext>
            </a:extLst>
          </p:cNvPr>
          <p:cNvSpPr txBox="1"/>
          <p:nvPr/>
        </p:nvSpPr>
        <p:spPr>
          <a:xfrm>
            <a:off x="2644881" y="216310"/>
            <a:ext cx="48840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tection of </a:t>
            </a:r>
            <a:r>
              <a:rPr kumimoji="1"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KPyV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in genomic DNA of three cell lines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E5FE21E9-0198-A5BD-B3D9-933EEC5C68C9}"/>
              </a:ext>
            </a:extLst>
          </p:cNvPr>
          <p:cNvSpPr txBox="1"/>
          <p:nvPr/>
        </p:nvSpPr>
        <p:spPr>
          <a:xfrm>
            <a:off x="1350554" y="2675836"/>
            <a:ext cx="22653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umn B : In-1024  Ct = 19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5DC7BA4D-EC75-6226-4518-941168DD849A}"/>
              </a:ext>
            </a:extLst>
          </p:cNvPr>
          <p:cNvSpPr txBox="1"/>
          <p:nvPr/>
        </p:nvSpPr>
        <p:spPr>
          <a:xfrm>
            <a:off x="1327354" y="5451981"/>
            <a:ext cx="23278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umn D : Vn1919  Ct = 21 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700A1375-1EC8-76F8-4677-78694918AE20}"/>
              </a:ext>
            </a:extLst>
          </p:cNvPr>
          <p:cNvSpPr txBox="1"/>
          <p:nvPr/>
        </p:nvSpPr>
        <p:spPr>
          <a:xfrm>
            <a:off x="5781368" y="2616844"/>
            <a:ext cx="22524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umn G : Vn-324  Ct = 22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843027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00</TotalTime>
  <Words>625</Words>
  <Application>Microsoft Office PowerPoint</Application>
  <PresentationFormat>画面に合わせる (4:3)</PresentationFormat>
  <Paragraphs>236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hioda</dc:creator>
  <cp:lastModifiedBy>Shioda</cp:lastModifiedBy>
  <cp:revision>6</cp:revision>
  <dcterms:created xsi:type="dcterms:W3CDTF">2024-09-20T05:47:23Z</dcterms:created>
  <dcterms:modified xsi:type="dcterms:W3CDTF">2025-08-20T03:09:26Z</dcterms:modified>
</cp:coreProperties>
</file>